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media/image2.png" ContentType="image/png"/>
  <Override PartName="/ppt/media/image3.wmf" ContentType="image/x-wmf"/>
  <Override PartName="/ppt/media/image4.png" ContentType="image/png"/>
  <Override PartName="/ppt/media/image5.wmf" ContentType="image/x-wmf"/>
  <Override PartName="/ppt/media/image6.png" ContentType="image/png"/>
  <Override PartName="/ppt/media/image7.wmf" ContentType="image/x-wmf"/>
  <Override PartName="/ppt/media/image8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0725AF4-9407-4137-AEBD-3E4E2EC053B6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7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1580909-BE49-4A30-BAF4-60EDB0F70415}" type="slidenum">
              <a:rPr b="0" lang="zh-CN" sz="1200" spc="-1" strike="noStrike">
                <a:solidFill>
                  <a:srgbClr val="000000"/>
                </a:solidFill>
                <a:latin typeface="Calibri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7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8041CB5-CC3A-4BFF-9876-882103102530}" type="slidenum">
              <a:rPr b="0" lang="zh-CN" sz="1200" spc="-1" strike="noStrike">
                <a:solidFill>
                  <a:srgbClr val="000000"/>
                </a:solidFill>
                <a:latin typeface="Calibri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79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A1FE633-54E3-4454-B582-D9244E56DCB4}" type="slidenum">
              <a:rPr b="0" lang="zh-CN" sz="1200" spc="-1" strike="noStrike">
                <a:solidFill>
                  <a:srgbClr val="000000"/>
                </a:solidFill>
                <a:latin typeface="Calibri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26CFAAE-4EB9-4957-8426-B451A97B4B5D}" type="slidenum">
              <a:rPr b="0" lang="zh-CN" sz="1200" spc="-1" strike="noStrike">
                <a:solidFill>
                  <a:srgbClr val="000000"/>
                </a:solidFill>
                <a:latin typeface="Calibri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7A212A-94E9-43F7-8322-AEC7F7367CC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D915A6-3BD1-43E3-834F-435478CC4AA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B44DA7-0790-42E7-9C11-BDE5FC4E794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9396BE-781A-43C7-A477-6219E071E03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6E5329-60BE-4346-B684-8915E28305A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9BFE56-FCC9-4C42-95B3-F55A8B6380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FD2965-6AC5-48AB-908E-81A749C87B7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1B7F20-FC06-411F-AA1B-002C6EAFDA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210BD3-B5E7-492D-8BA2-3401066CE98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B24163-1085-48C5-954B-5BAC58665E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591A4C-BD58-44ED-9441-C41DD1B96A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B07940-3D14-44D8-8291-2C46858817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20A4A8B-953C-425D-B887-551B97D4A09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image" Target="../media/image2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3.wmf"/><Relationship Id="rId3" Type="http://schemas.openxmlformats.org/officeDocument/2006/relationships/image" Target="../media/image4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5.wmf"/><Relationship Id="rId3" Type="http://schemas.openxmlformats.org/officeDocument/2006/relationships/image" Target="../media/image6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7.wmf"/><Relationship Id="rId3" Type="http://schemas.openxmlformats.org/officeDocument/2006/relationships/image" Target="../media/image8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4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Object 2"/>
          <p:cNvGraphicFramePr/>
          <p:nvPr/>
        </p:nvGraphicFramePr>
        <p:xfrm>
          <a:off x="457200" y="152280"/>
          <a:ext cx="8305920" cy="55706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9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57200" y="152280"/>
                    <a:ext cx="8305920" cy="5570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0" name="TextBox 24"/>
          <p:cNvSpPr/>
          <p:nvPr/>
        </p:nvSpPr>
        <p:spPr>
          <a:xfrm>
            <a:off x="3291480" y="762120"/>
            <a:ext cx="2873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宋体"/>
              </a:rPr>
              <a:t>ST – 70% Variance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27"/>
          <p:cNvSpPr/>
          <p:nvPr/>
        </p:nvSpPr>
        <p:spPr>
          <a:xfrm>
            <a:off x="1451520" y="609480"/>
            <a:ext cx="4579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2" name="Table 28" descr=""/>
          <p:cNvPicPr/>
          <p:nvPr/>
        </p:nvPicPr>
        <p:blipFill>
          <a:blip r:embed="rId3"/>
          <a:stretch/>
        </p:blipFill>
        <p:spPr>
          <a:xfrm>
            <a:off x="1378080" y="5529240"/>
            <a:ext cx="6772320" cy="1785960"/>
          </a:xfrm>
          <a:prstGeom prst="rect">
            <a:avLst/>
          </a:prstGeom>
          <a:ln w="0">
            <a:noFill/>
          </a:ln>
        </p:spPr>
      </p:pic>
      <p:sp>
        <p:nvSpPr>
          <p:cNvPr id="53" name="TextBox 6"/>
          <p:cNvSpPr/>
          <p:nvPr/>
        </p:nvSpPr>
        <p:spPr>
          <a:xfrm>
            <a:off x="3240" y="0"/>
            <a:ext cx="1630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Mi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et al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, Figure S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4" name="Object 2"/>
          <p:cNvGraphicFramePr/>
          <p:nvPr/>
        </p:nvGraphicFramePr>
        <p:xfrm>
          <a:off x="457200" y="152280"/>
          <a:ext cx="8305920" cy="55706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5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57200" y="152280"/>
                    <a:ext cx="8305920" cy="5570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6" name="TextBox 24"/>
          <p:cNvSpPr/>
          <p:nvPr/>
        </p:nvSpPr>
        <p:spPr>
          <a:xfrm>
            <a:off x="3291480" y="762120"/>
            <a:ext cx="2873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宋体"/>
              </a:rPr>
              <a:t>ST – 95% Variance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27"/>
          <p:cNvSpPr/>
          <p:nvPr/>
        </p:nvSpPr>
        <p:spPr>
          <a:xfrm>
            <a:off x="1450800" y="609480"/>
            <a:ext cx="4366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8" name="Table 29" descr=""/>
          <p:cNvPicPr/>
          <p:nvPr/>
        </p:nvPicPr>
        <p:blipFill>
          <a:blip r:embed="rId3"/>
          <a:stretch/>
        </p:blipFill>
        <p:spPr>
          <a:xfrm>
            <a:off x="1378080" y="5529240"/>
            <a:ext cx="6772320" cy="1401840"/>
          </a:xfrm>
          <a:prstGeom prst="rect">
            <a:avLst/>
          </a:prstGeom>
          <a:ln w="0">
            <a:noFill/>
          </a:ln>
        </p:spPr>
      </p:pic>
      <p:sp>
        <p:nvSpPr>
          <p:cNvPr id="59" name="TextBox 6"/>
          <p:cNvSpPr/>
          <p:nvPr/>
        </p:nvSpPr>
        <p:spPr>
          <a:xfrm>
            <a:off x="3240" y="0"/>
            <a:ext cx="1630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Mi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et al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, Figure S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0" name="Object 2"/>
          <p:cNvGraphicFramePr/>
          <p:nvPr/>
        </p:nvGraphicFramePr>
        <p:xfrm>
          <a:off x="457200" y="152280"/>
          <a:ext cx="8305920" cy="55706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61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57200" y="152280"/>
                    <a:ext cx="8305920" cy="5570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2" name="TextBox 24"/>
          <p:cNvSpPr/>
          <p:nvPr/>
        </p:nvSpPr>
        <p:spPr>
          <a:xfrm>
            <a:off x="2601720" y="685800"/>
            <a:ext cx="4018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宋体"/>
              </a:rPr>
              <a:t>ST + HS – 70% of Variance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27"/>
          <p:cNvSpPr/>
          <p:nvPr/>
        </p:nvSpPr>
        <p:spPr>
          <a:xfrm>
            <a:off x="1450440" y="609480"/>
            <a:ext cx="423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Calibri"/>
              </a:rPr>
              <a:t>C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4" name="Table 28" descr=""/>
          <p:cNvPicPr/>
          <p:nvPr/>
        </p:nvPicPr>
        <p:blipFill>
          <a:blip r:embed="rId3"/>
          <a:stretch/>
        </p:blipFill>
        <p:spPr>
          <a:xfrm>
            <a:off x="1371600" y="5450040"/>
            <a:ext cx="6778800" cy="1328760"/>
          </a:xfrm>
          <a:prstGeom prst="rect">
            <a:avLst/>
          </a:prstGeom>
          <a:ln w="0">
            <a:noFill/>
          </a:ln>
        </p:spPr>
      </p:pic>
      <p:sp>
        <p:nvSpPr>
          <p:cNvPr id="65" name="TextBox 6"/>
          <p:cNvSpPr/>
          <p:nvPr/>
        </p:nvSpPr>
        <p:spPr>
          <a:xfrm>
            <a:off x="3240" y="0"/>
            <a:ext cx="1630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Mi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et al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, Figure S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6" name="Object 2"/>
          <p:cNvGraphicFramePr/>
          <p:nvPr/>
        </p:nvGraphicFramePr>
        <p:xfrm>
          <a:off x="380880" y="0"/>
          <a:ext cx="8305920" cy="55706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67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80880" y="0"/>
                    <a:ext cx="8305920" cy="5570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8" name="TextBox 24"/>
          <p:cNvSpPr/>
          <p:nvPr/>
        </p:nvSpPr>
        <p:spPr>
          <a:xfrm>
            <a:off x="2601720" y="609480"/>
            <a:ext cx="4018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宋体"/>
              </a:rPr>
              <a:t>ST + HS – 95% of Variance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27"/>
          <p:cNvSpPr/>
          <p:nvPr/>
        </p:nvSpPr>
        <p:spPr>
          <a:xfrm>
            <a:off x="1375200" y="457200"/>
            <a:ext cx="4687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Calibri"/>
              </a:rPr>
              <a:t>D</a:t>
            </a:r>
            <a:endParaRPr b="0" lang="en-US" sz="3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0" name="Table 28" descr=""/>
          <p:cNvPicPr/>
          <p:nvPr/>
        </p:nvPicPr>
        <p:blipFill>
          <a:blip r:embed="rId3"/>
          <a:stretch/>
        </p:blipFill>
        <p:spPr>
          <a:xfrm>
            <a:off x="1298520" y="5376960"/>
            <a:ext cx="6851880" cy="1633320"/>
          </a:xfrm>
          <a:prstGeom prst="rect">
            <a:avLst/>
          </a:prstGeom>
          <a:ln w="0">
            <a:noFill/>
          </a:ln>
        </p:spPr>
      </p:pic>
      <p:sp>
        <p:nvSpPr>
          <p:cNvPr id="71" name="TextBox 7"/>
          <p:cNvSpPr/>
          <p:nvPr/>
        </p:nvSpPr>
        <p:spPr>
          <a:xfrm>
            <a:off x="3240" y="0"/>
            <a:ext cx="1630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Mi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et al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, Figure S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/>
  <dc:description/>
  <dc:language>en-US</dc:language>
  <cp:lastModifiedBy>qim3</cp:lastModifiedBy>
  <dcterms:modified xsi:type="dcterms:W3CDTF">2010-11-20T01:32:45Z</dcterms:modified>
  <cp:revision>6</cp:revision>
  <dc:subject/>
  <dc:title>Slide 1</dc:title>
</cp:coreProperties>
</file>